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bookmarkIdSeed="2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505" r:id="rId3"/>
  </p:sldIdLst>
  <p:sldSz cx="9144000" cy="6858000" type="screen4x3"/>
  <p:notesSz cx="6797675" cy="9926320"/>
  <p:custDataLst>
    <p:tags r:id="rId9"/>
  </p:custDataLst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CBE9"/>
    <a:srgbClr val="E5C5F3"/>
    <a:srgbClr val="D1EBFD"/>
    <a:srgbClr val="93CDFE"/>
    <a:srgbClr val="4764A5"/>
    <a:srgbClr val="95CDFF"/>
    <a:srgbClr val="C9A6E4"/>
    <a:srgbClr val="FFFFFF"/>
    <a:srgbClr val="E69190"/>
    <a:srgbClr val="DFED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391" autoAdjust="0"/>
  </p:normalViewPr>
  <p:slideViewPr>
    <p:cSldViewPr snapToGrid="0" showGuides="1">
      <p:cViewPr varScale="1">
        <p:scale>
          <a:sx n="115" d="100"/>
          <a:sy n="115" d="100"/>
        </p:scale>
        <p:origin x="1476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336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1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709" y="1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/>
          <a:lstStyle>
            <a:lvl1pPr algn="r">
              <a:defRPr sz="1200"/>
            </a:lvl1pPr>
          </a:lstStyle>
          <a:p>
            <a:fld id="{8C46219E-D83A-41C0-9DC5-0B2808AE6EAA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" y="9428573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709" y="9428573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 anchor="b"/>
          <a:lstStyle>
            <a:lvl1pPr algn="r">
              <a:defRPr sz="1200"/>
            </a:lvl1pPr>
          </a:lstStyle>
          <a:p>
            <a:fld id="{7CEFD639-A456-4D1D-ADC3-7F8A141BA253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3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4" y="3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/>
          <a:lstStyle>
            <a:lvl1pPr algn="r">
              <a:defRPr sz="1300"/>
            </a:lvl1pPr>
          </a:lstStyle>
          <a:p>
            <a:fld id="{41995B93-3BDA-4DC1-A0AD-B868635495F7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38250"/>
            <a:ext cx="44672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59" tIns="47780" rIns="95559" bIns="4778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8"/>
            <a:ext cx="5438140" cy="3908614"/>
          </a:xfrm>
          <a:prstGeom prst="rect">
            <a:avLst/>
          </a:prstGeom>
        </p:spPr>
        <p:txBody>
          <a:bodyPr vert="horz" lIns="95559" tIns="47780" rIns="95559" bIns="47780" rtlCol="0"/>
          <a:lstStyle/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 anchor="b"/>
          <a:lstStyle>
            <a:lvl1pPr algn="r">
              <a:defRPr sz="1300"/>
            </a:lvl1pPr>
          </a:lstStyle>
          <a:p>
            <a:fld id="{2C6FDD75-2E7B-4E86-B837-6FBA6F63F75B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重要的用</a:t>
            </a:r>
            <a:r>
              <a:rPr lang="en-US" altLang="zh-CN" dirty="0"/>
              <a:t>box</a:t>
            </a:r>
            <a:r>
              <a:rPr lang="zh-CN" altLang="en-US" dirty="0"/>
              <a:t>标出</a:t>
            </a:r>
            <a:endParaRPr lang="en-US" altLang="zh-CN" dirty="0"/>
          </a:p>
          <a:p>
            <a:endParaRPr lang="en-US" altLang="ko-KR" dirty="0"/>
          </a:p>
          <a:p>
            <a:r>
              <a:rPr lang="en-US" altLang="ko-KR" dirty="0"/>
              <a:t>Candidate genes were selected as hub genes by gene co-expression network. Finally, candidate genes were identified by these hub genes. (red)</a:t>
            </a:r>
            <a:endParaRPr lang="en-US" altLang="ko-KR" dirty="0"/>
          </a:p>
          <a:p>
            <a:r>
              <a:rPr lang="en-US" altLang="ko-KR" dirty="0"/>
              <a:t>There are some important proteins in my network that function as ……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6FDD75-2E7B-4E86-B837-6FBA6F63F75B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EBE44-C8A1-46D5-94B7-0A19D9CB8F77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4C01F-E4DF-4F93-AE9D-CE4EFFCDE5E6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D369-078A-4FF0-AF23-9B57C0DC74AC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97D27-0F6C-4588-87CD-B17B11862D5E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8714-C533-4D25-A425-575EB2553755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AF2E-588F-4574-8640-451F19F6797B}" type="datetime1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740E9-E684-4879-AC1A-027D0F57D12C}" type="datetime1">
              <a:rPr lang="ko-KR" altLang="en-US" smtClean="0"/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F6F07-08D8-4352-80A8-D6CA92EAF940}" type="datetime1">
              <a:rPr lang="ko-KR" altLang="en-US" smtClean="0"/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D9ABB-2B96-441D-8A23-EA02D08D861A}" type="datetime1">
              <a:rPr lang="ko-KR" altLang="en-US" smtClean="0"/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en-US" smtClean="0"/>
            </a:fld>
            <a:endParaRPr lang="en-US" dirty="0"/>
          </a:p>
        </p:txBody>
      </p:sp>
      <p:sp>
        <p:nvSpPr>
          <p:cNvPr id="5" name="TextBox 4"/>
          <p:cNvSpPr txBox="1"/>
          <p:nvPr userDrawn="1"/>
        </p:nvSpPr>
        <p:spPr>
          <a:xfrm>
            <a:off x="8636057" y="403268"/>
            <a:ext cx="507943" cy="2769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l"/>
            <a:r>
              <a:rPr lang="en-US" sz="1300" dirty="0"/>
              <a:t>/39</a:t>
            </a:r>
            <a:endParaRPr lang="en-US" sz="1300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5CE22-16BC-42DE-BDF0-C7E49D6F164E}" type="datetime1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66AD0-4F21-44E9-A6D4-BFF0E3F2D54F}" type="datetime1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3A7FE-D276-4461-821C-5A41A6583C2C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6028" y="0"/>
            <a:ext cx="6671945" cy="60325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-635" y="6195060"/>
            <a:ext cx="9144635" cy="645160"/>
          </a:xfrm>
          <a:prstGeom prst="rect">
            <a:avLst/>
          </a:prstGeom>
        </p:spPr>
        <p:txBody>
          <a:bodyPr wrap="square">
            <a:spAutoFit/>
          </a:bodyPr>
          <a:p>
            <a:pPr indent="0" defTabSz="266700" fontAlgn="auto" latinLnBrk="0">
              <a:lnSpc>
                <a:spcPct val="10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latin typeface="Times New Roman" panose="02020603050405020304"/>
                <a:ea typeface="Times New Roman" panose="02020603050405020304"/>
              </a:rPr>
              <a:t>Supplementary Figure 5</a:t>
            </a:r>
            <a:r>
              <a:rPr lang="en-US" altLang="ko-KR" sz="1200" b="1">
                <a:latin typeface="Times New Roman" panose="02020603050405020304"/>
                <a:ea typeface="Times New Roman" panose="02020603050405020304"/>
              </a:rPr>
              <a:t>.</a:t>
            </a:r>
            <a:r>
              <a:rPr lang="en-US" altLang="ko-KR" sz="1200">
                <a:latin typeface="Times New Roman" panose="02020603050405020304"/>
                <a:ea typeface="Calibri" panose="020F0502020204030204"/>
              </a:rPr>
              <a:t> </a:t>
            </a:r>
            <a:r>
              <a:rPr lang="en-US" altLang="ko-KR" sz="1200">
                <a:latin typeface="Times New Roman" panose="02020603050405020304"/>
                <a:ea typeface="Times New Roman" panose="02020603050405020304"/>
              </a:rPr>
              <a:t>The gene co-expression network of hub genes. The network was constructed using Cytoscape 3.4 software. Genes contained in significant GO terms were analyzed and identified by gene co-expression network. Nodes represent the gene; edges indicate the interaction between genes. The edge </a:t>
            </a:r>
            <a:r>
              <a:rPr lang="en-US" altLang="zh-CN" sz="1200">
                <a:latin typeface="Times New Roman" panose="02020603050405020304"/>
                <a:ea typeface="Times New Roman" panose="02020603050405020304"/>
              </a:rPr>
              <a:t>thickness </a:t>
            </a:r>
            <a:r>
              <a:rPr lang="en-US" altLang="ko-KR" sz="1200">
                <a:latin typeface="Times New Roman" panose="02020603050405020304"/>
                <a:ea typeface="Times New Roman" panose="02020603050405020304"/>
              </a:rPr>
              <a:t>are proportional to degree and connection strength.</a:t>
            </a:r>
            <a:endParaRPr lang="en-US" altLang="ko-KR" sz="1200">
              <a:latin typeface="Times New Roman" panose="02020603050405020304"/>
              <a:ea typeface="Times New Roman" panose="02020603050405020304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cbb28d3e-cd92-42c5-a40b-1275b12b3187"/>
  <p:tag name="COMMONDATA" val="eyJoZGlkIjoiZGFiYjlkYzc4N2RkMzFhNmZmMzMzZjQyN2U1ZTZhYWUifQ=="/>
</p:tagLst>
</file>

<file path=ppt/theme/theme1.xml><?xml version="1.0" encoding="utf-8"?>
<a:theme xmlns:a="http://schemas.openxmlformats.org/drawingml/2006/main" name="Office Theme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9</Words>
  <Application>WPS 演示</Application>
  <PresentationFormat>화면 슬라이드 쇼(4:3)</PresentationFormat>
  <Paragraphs>2</Paragraphs>
  <Slides>1</Slides>
  <Notes>4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Malgun Gothic</vt:lpstr>
      <vt:lpstr>Calibri Light</vt:lpstr>
      <vt:lpstr>等线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PRESENT</cp:lastModifiedBy>
  <cp:revision>812</cp:revision>
  <cp:lastPrinted>2023-05-18T02:12:00Z</cp:lastPrinted>
  <dcterms:created xsi:type="dcterms:W3CDTF">2018-01-24T06:41:00Z</dcterms:created>
  <dcterms:modified xsi:type="dcterms:W3CDTF">2025-10-05T10:24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C01694E1EFE4BB988246F32DA9EBD06_12</vt:lpwstr>
  </property>
  <property fmtid="{D5CDD505-2E9C-101B-9397-08002B2CF9AE}" pid="3" name="KSOProductBuildVer">
    <vt:lpwstr>2052-12.1.0.22529</vt:lpwstr>
  </property>
</Properties>
</file>